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61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52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4244" autoAdjust="0"/>
    <p:restoredTop sz="95214" autoAdjust="0"/>
  </p:normalViewPr>
  <p:slideViewPr>
    <p:cSldViewPr showGuides="1">
      <p:cViewPr varScale="1">
        <p:scale>
          <a:sx n="85" d="100"/>
          <a:sy n="85" d="100"/>
        </p:scale>
        <p:origin x="984" y="72"/>
      </p:cViewPr>
      <p:guideLst>
        <p:guide orient="horz" pos="346"/>
        <p:guide pos="52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4021142" y="2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/>
          <a:lstStyle>
            <a:lvl1pPr algn="r">
              <a:defRPr sz="1100"/>
            </a:lvl1pPr>
          </a:lstStyle>
          <a:p>
            <a:fld id="{7B015BB1-1E7A-4E6C-89B7-0C5BC5328040}" type="datetimeFigureOut">
              <a:rPr kumimoji="1" lang="ja-JP" altLang="en-US" smtClean="0"/>
              <a:t>2017/3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721853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 anchor="b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4021142" y="9721853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 anchor="b"/>
          <a:lstStyle>
            <a:lvl1pPr algn="r">
              <a:defRPr sz="1100"/>
            </a:lvl1pPr>
          </a:lstStyle>
          <a:p>
            <a:fld id="{5F431AF3-5A39-4883-B7C5-8AAE25E8C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8518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6" y="1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/>
          <a:lstStyle>
            <a:lvl1pPr algn="r">
              <a:defRPr sz="1100"/>
            </a:lvl1pPr>
          </a:lstStyle>
          <a:p>
            <a:fld id="{6048D5DD-01E0-4355-93B1-2C55B9C27FBA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0600" y="766763"/>
            <a:ext cx="5118100" cy="3838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62" tIns="47332" rIns="94662" bIns="4733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1" y="4861442"/>
            <a:ext cx="5679440" cy="4605576"/>
          </a:xfrm>
          <a:prstGeom prst="rect">
            <a:avLst/>
          </a:prstGeom>
        </p:spPr>
        <p:txBody>
          <a:bodyPr vert="horz" lIns="94662" tIns="47332" rIns="94662" bIns="47332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721107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 anchor="b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6" y="9721107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 anchor="b"/>
          <a:lstStyle>
            <a:lvl1pPr algn="r">
              <a:defRPr sz="1100"/>
            </a:lvl1pPr>
          </a:lstStyle>
          <a:p>
            <a:fld id="{95BD2EC4-4567-48DF-AA7C-ED31B69D9C6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46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BD2EC4-4567-48DF-AA7C-ED31B69D9C60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7641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869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732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335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596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611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238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722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844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352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9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729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132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2869217"/>
              </p:ext>
            </p:extLst>
          </p:nvPr>
        </p:nvGraphicFramePr>
        <p:xfrm>
          <a:off x="250821" y="437046"/>
          <a:ext cx="8667720" cy="60353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0000"/>
                <a:gridCol w="900000"/>
                <a:gridCol w="1044000"/>
                <a:gridCol w="684000"/>
                <a:gridCol w="230253"/>
                <a:gridCol w="684000"/>
                <a:gridCol w="684000"/>
                <a:gridCol w="220489"/>
                <a:gridCol w="684000"/>
                <a:gridCol w="684000"/>
                <a:gridCol w="220489"/>
                <a:gridCol w="684000"/>
                <a:gridCol w="684000"/>
                <a:gridCol w="220489"/>
                <a:gridCol w="684000"/>
                <a:gridCol w="180000"/>
              </a:tblGrid>
              <a:tr h="324000"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cancer </a:t>
                      </a:r>
                      <a:endParaRPr lang="en-US" sz="120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</a:t>
                      </a:r>
                    </a:p>
                    <a:p>
                      <a:pPr algn="ctr" rtl="0" fontAlgn="ctr"/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µg/m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sidual </a:t>
                      </a:r>
                      <a:r>
                        <a:rPr lang="ja-JP" alt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centration in water </a:t>
                      </a: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µg/mL)</a:t>
                      </a:r>
                      <a:endParaRPr lang="en-US" altLang="ja-JP" sz="12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esidual concentration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in urine </a:t>
                      </a: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µg/mL)</a:t>
                      </a:r>
                      <a:endParaRPr lang="en-US" altLang="ja-JP" sz="12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－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+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－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+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8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52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7.3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0.7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9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81.8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9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7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.0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3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4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2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4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6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4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9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9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2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7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5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7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3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8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DC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54.0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5.1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29.0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8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78.6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7.7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15.4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8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4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6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0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4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DP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12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91.7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46.1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35.8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1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12.4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8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8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2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1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6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1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FU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9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6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6.2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8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4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6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-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0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3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2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5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3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8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4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321788" y="6544394"/>
            <a:ext cx="87849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erical value indicated mean ± standar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 (n=4) </a:t>
            </a:r>
            <a:endParaRPr lang="ja-JP" altLang="en-US" sz="1200" dirty="0"/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1788" y="112652"/>
            <a:ext cx="8086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ndix1. 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sorption properties of the activated carbon to the urinary anticancer drug. </a:t>
            </a:r>
            <a:endParaRPr lang="en-US" altLang="ja-JP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6133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00</TotalTime>
  <Words>431</Words>
  <Application>Microsoft Office PowerPoint</Application>
  <PresentationFormat>画面に合わせる (4:3)</PresentationFormat>
  <Paragraphs>38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ya</dc:creator>
  <cp:lastModifiedBy>junya</cp:lastModifiedBy>
  <cp:revision>584</cp:revision>
  <cp:lastPrinted>2017-01-25T01:09:51Z</cp:lastPrinted>
  <dcterms:created xsi:type="dcterms:W3CDTF">2016-11-19T06:04:05Z</dcterms:created>
  <dcterms:modified xsi:type="dcterms:W3CDTF">2017-03-01T09:34:08Z</dcterms:modified>
</cp:coreProperties>
</file>